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5FCCB4-515B-4FAE-8D0D-AA6B6EBBD0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8E2FA17-35FF-449C-980F-884B960527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576318-F117-4ADC-B20B-62A8F6336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F6AF80-E404-4223-A575-D0F93EEB0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5D0E3A-6D38-42CD-A2C4-20C67F80E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0831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3D8727-2890-4775-B980-1B00ED65A0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BC57C6-4449-416D-B019-BDFF456EE7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DC0EFC-A66D-410A-BD4B-3E7C8F6F9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72828B-EF6F-4948-BBBB-024483513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63BAD6-F39F-4A2F-9FDA-2814712F6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8275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D49111-9EF1-4AFB-BC41-EA2959EC56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71E63C-BBA6-4A08-BCFF-531176199E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FC016E-562C-4ECC-95C9-2776ACDD1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345FAA-B5C4-48AF-80A2-9EFF285C2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6122A7-1F24-445E-8C2A-CF9EAEC43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3632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7FB68A-91CB-41F0-AC67-6F9DEBA398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F4B8B9-26A2-4905-A136-D205C134A6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7444F2-051F-45EB-9269-1895A25C2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047551-ECD7-40F8-991D-89EEECEE7E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2442EB-3758-4FBC-9BCB-E163B1B22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9616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1A526A-0D94-461B-AEE0-20301F7DB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EC2F6E-672E-4750-BC9A-CB13D73D7B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A9443C-D150-4948-9576-1B0453A7A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313B9E-08D0-4107-AF20-0708B27DC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BEFD9F-275F-449B-8C75-2317272BF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8176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AD5C8F-AF7F-4DEF-9E47-FDD08CBD67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AD23D0-AC6B-45E5-B99E-C9E3E13887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D01299-EA75-4182-9BBD-7A2A85D645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B866E2-F17D-487C-AB71-0349B6F29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826430-1CBE-43C7-9019-104CE0C1F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BA025E-3CB2-4D0C-9C45-230658010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8467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228C94-C8D8-4D58-B1E6-12757CA6A1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AA5CB5-C624-4FA2-A3D6-1F50042554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4C18C5-EF25-45BE-AD17-B37ACCF2DA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4610EF4-2A41-4379-BC72-0C810C782C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44FD09-1DCE-4297-9590-70E7FF34C5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E96D03-BFF9-445A-98F4-25F740519D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0E29BB-02E6-4CFD-8292-EE5139AEE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94F0FE-DE19-4245-B047-D3D904F41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2530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CD767D-B46F-49F2-8193-DA1E4EEE0D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2862017-56C8-481B-AAD6-E815E74C6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9042FF-C53A-4796-85A9-DC5DB89E1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2E9153-1F16-4AC0-B02B-C797850165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8479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B0CA47-DABC-4467-B87E-A49F48DEB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42AA6C3-F377-440E-AEC2-17643F723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C9F37BC-260D-4596-8AC1-370FB155BA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3345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7C1A9C-5E5D-4444-948D-C3BFD42C8D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B237CA-CBC2-44C4-ACA8-EC65836630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F916F9-7758-48E1-B42C-9D7F784398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FDAA92-AB76-42BD-A2A8-813495B4C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E5D4A6-92A4-4281-B7F6-CA0C7CED06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38AA39-5920-4D38-A10B-EB19E095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43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C4DAD-0E08-4831-B405-2DE3DB8C2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9313F76-A01D-42F9-94E7-58AF9F47C4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6E17AC-B680-4EDE-8CA9-F10ABB8A5F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3F2E22-5E84-4D18-AD43-543D0C5CF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DF4E2A-942C-49E7-AC0A-794990D83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158C40-119F-43B1-A7C5-DE93491A7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9680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8542EE-2F13-4183-880A-F7F2A5106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736E4A-42F7-4137-AE17-FB228D7517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9803BE-F122-4241-B39F-A0001360A8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79147-670F-4BA6-BBF3-5041D3B095D6}" type="datetimeFigureOut">
              <a:rPr lang="en-GB" smtClean="0"/>
              <a:t>23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FBE415-A511-4755-B3BA-58C3DD2B24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9070D8-6886-4320-AFDE-CED3661948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978F6C-8389-4C50-9205-F0203670E3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173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FB8F6398-5B75-405E-A1D8-7DF5831B3A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6615863"/>
              </p:ext>
            </p:extLst>
          </p:nvPr>
        </p:nvGraphicFramePr>
        <p:xfrm>
          <a:off x="2970883" y="753787"/>
          <a:ext cx="5884034" cy="37861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20463">
                  <a:extLst>
                    <a:ext uri="{9D8B030D-6E8A-4147-A177-3AD203B41FA5}">
                      <a16:colId xmlns:a16="http://schemas.microsoft.com/office/drawing/2014/main" val="2429464227"/>
                    </a:ext>
                  </a:extLst>
                </a:gridCol>
                <a:gridCol w="1068858">
                  <a:extLst>
                    <a:ext uri="{9D8B030D-6E8A-4147-A177-3AD203B41FA5}">
                      <a16:colId xmlns:a16="http://schemas.microsoft.com/office/drawing/2014/main" val="3739902064"/>
                    </a:ext>
                  </a:extLst>
                </a:gridCol>
                <a:gridCol w="1125855">
                  <a:extLst>
                    <a:ext uri="{9D8B030D-6E8A-4147-A177-3AD203B41FA5}">
                      <a16:colId xmlns:a16="http://schemas.microsoft.com/office/drawing/2014/main" val="2957145106"/>
                    </a:ext>
                  </a:extLst>
                </a:gridCol>
                <a:gridCol w="1068858">
                  <a:extLst>
                    <a:ext uri="{9D8B030D-6E8A-4147-A177-3AD203B41FA5}">
                      <a16:colId xmlns:a16="http://schemas.microsoft.com/office/drawing/2014/main" val="2471751852"/>
                    </a:ext>
                  </a:extLst>
                </a:gridCol>
              </a:tblGrid>
              <a:tr h="388287">
                <a:tc>
                  <a:txBody>
                    <a:bodyPr/>
                    <a:lstStyle/>
                    <a:p>
                      <a:endParaRPr lang="en-GB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Median SBA titre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Fold Change 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583829"/>
                  </a:ext>
                </a:extLst>
              </a:tr>
              <a:tr h="388287">
                <a:tc>
                  <a:txBody>
                    <a:bodyPr/>
                    <a:lstStyle/>
                    <a:p>
                      <a:endParaRPr lang="en-GB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Pre-vaccination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D28 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PV to D2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7957997"/>
                  </a:ext>
                </a:extLst>
              </a:tr>
              <a:tr h="38828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Vi-PS (all, </a:t>
                      </a:r>
                      <a:r>
                        <a:rPr lang="en-GB" sz="1000" i="1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</a:t>
                      </a:r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=35)</a:t>
                      </a:r>
                    </a:p>
                    <a:p>
                      <a:endParaRPr lang="en-GB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25.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/>
                      <a:r>
                        <a:rPr lang="en-GB" sz="1000" dirty="0"/>
                        <a:t>1,848.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.24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055784"/>
                  </a:ext>
                </a:extLst>
              </a:tr>
              <a:tr h="38828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Vi-PS (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</a:rPr>
                        <a:t>nTD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, </a:t>
                      </a:r>
                      <a:r>
                        <a:rPr lang="en-GB" sz="1000" i="1" dirty="0">
                          <a:solidFill>
                            <a:schemeClr val="tx1"/>
                          </a:solidFill>
                        </a:rPr>
                        <a:t>n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=22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48.6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,943.0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.05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3975392"/>
                  </a:ext>
                </a:extLst>
              </a:tr>
              <a:tr h="38828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Vi-PS (TD, </a:t>
                      </a:r>
                      <a:r>
                        <a:rPr lang="en-GB" sz="1000" i="1" dirty="0">
                          <a:solidFill>
                            <a:schemeClr val="tx1"/>
                          </a:solidFill>
                        </a:rPr>
                        <a:t>n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=13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28.3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,713.0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.73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9067138"/>
                  </a:ext>
                </a:extLst>
              </a:tr>
              <a:tr h="38828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Vi-TT (all, </a:t>
                      </a:r>
                      <a:r>
                        <a:rPr lang="en-GB" sz="1000" i="1" dirty="0">
                          <a:solidFill>
                            <a:schemeClr val="tx1"/>
                          </a:solidFill>
                        </a:rPr>
                        <a:t>n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=37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,368.0	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,001.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46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7248772"/>
                  </a:ext>
                </a:extLst>
              </a:tr>
              <a:tr h="38828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Vi-TT (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</a:rPr>
                        <a:t>nTD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, </a:t>
                      </a:r>
                      <a:r>
                        <a:rPr lang="en-GB" sz="1000" i="1" dirty="0">
                          <a:solidFill>
                            <a:schemeClr val="tx1"/>
                          </a:solidFill>
                        </a:rPr>
                        <a:t>n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=24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,823.0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,546.0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40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3212643"/>
                  </a:ext>
                </a:extLst>
              </a:tr>
              <a:tr h="38828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Vi-TT (TD, </a:t>
                      </a:r>
                      <a:r>
                        <a:rPr lang="en-GB" sz="1000" i="1" dirty="0">
                          <a:solidFill>
                            <a:schemeClr val="tx1"/>
                          </a:solidFill>
                        </a:rPr>
                        <a:t>n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=13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30.7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,339.0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61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3641422"/>
                  </a:ext>
                </a:extLst>
              </a:tr>
              <a:tr h="238946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All 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</a:rPr>
                        <a:t>nTD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 (</a:t>
                      </a:r>
                      <a:r>
                        <a:rPr lang="en-GB" sz="1000" i="1" dirty="0">
                          <a:solidFill>
                            <a:schemeClr val="tx1"/>
                          </a:solidFill>
                        </a:rPr>
                        <a:t>n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=46)</a:t>
                      </a:r>
                    </a:p>
                    <a:p>
                      <a:pPr algn="l"/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,171.0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,065.0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76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6017201"/>
                  </a:ext>
                </a:extLst>
              </a:tr>
              <a:tr h="238946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All TD </a:t>
                      </a:r>
                      <a:r>
                        <a:rPr lang="en-GB" sz="1000" i="1" dirty="0">
                          <a:solidFill>
                            <a:schemeClr val="tx1"/>
                          </a:solidFill>
                        </a:rPr>
                        <a:t>(n=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</a:rPr>
                        <a:t>26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04.5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algn="ctr" defTabSz="914400" rtl="0" eaLnBrk="1" fontAlgn="b" latinLnBrk="0" hangingPunct="1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,523.0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.16</a:t>
                      </a:r>
                    </a:p>
                  </a:txBody>
                  <a:tcPr marL="6350" marR="6350" marT="635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877850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C05D9A5-41BD-4F84-B041-03CD1B6BC289}"/>
              </a:ext>
            </a:extLst>
          </p:cNvPr>
          <p:cNvSpPr txBox="1"/>
          <p:nvPr/>
        </p:nvSpPr>
        <p:spPr>
          <a:xfrm>
            <a:off x="2970884" y="4766172"/>
            <a:ext cx="54963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Table 1: </a:t>
            </a:r>
            <a:r>
              <a:rPr lang="en-GB" sz="1200" dirty="0"/>
              <a:t>Table summarising the SBA titres at pre-vaccination and D28,</a:t>
            </a:r>
          </a:p>
          <a:p>
            <a:r>
              <a:rPr lang="en-GB" sz="1200" dirty="0"/>
              <a:t> and fold changes in different groups.  </a:t>
            </a:r>
          </a:p>
        </p:txBody>
      </p:sp>
    </p:spTree>
    <p:extLst>
      <p:ext uri="{BB962C8B-B14F-4D97-AF65-F5344CB8AC3E}">
        <p14:creationId xmlns:p14="http://schemas.microsoft.com/office/powerpoint/2010/main" val="26182770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19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 Jones</dc:creator>
  <cp:lastModifiedBy>Elizabeth Jones</cp:lastModifiedBy>
  <cp:revision>2</cp:revision>
  <dcterms:created xsi:type="dcterms:W3CDTF">2021-05-17T16:26:51Z</dcterms:created>
  <dcterms:modified xsi:type="dcterms:W3CDTF">2021-06-23T11:35:02Z</dcterms:modified>
</cp:coreProperties>
</file>